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4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24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3943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0685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2504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3299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0759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0935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4304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3885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8105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96794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6261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249D1-CAA3-454A-8323-D50C743ED6F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9F8AD-58B4-4FAE-A084-886B80D77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9198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680" y="4633626"/>
            <a:ext cx="1196826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PMN enrichment measurement by flow cytometry (n=4; representative)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MN enrichment was carried out by double gradient centrifugation. A single cell suspension was (1x10^5 cells) stained with the following markers: CD15-BV421 (Pan-granulocyte), CD66b-FITC (Neutrophil maturity), CD16-APC (Neutrophil FC receptor), CCR3-APC-Cy7 (Eosinophil and basophil), and CD56-PerCP (NK cell). PMN population was gated based on the FSC-SSC scatter plot. The CD15+ and CD66b+ double positive cells were gated using a quadrant plot. This population indicated neutrophil enrichment, which was an average of 85.45% (± 6.20%). We also looked at contaminating eosinophil/basophil (CCR3) and NK-cell (CD56) populations by plotting against CD16 (neutrophil specific), and found them to be 1.14% (± 1.02%) and 1.9% (± 2.00 %) respectively. 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80" y="287438"/>
            <a:ext cx="12114639" cy="3721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7015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5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-pc</dc:creator>
  <cp:lastModifiedBy>Aditya Roshan</cp:lastModifiedBy>
  <cp:revision>8</cp:revision>
  <dcterms:created xsi:type="dcterms:W3CDTF">2022-05-03T09:24:36Z</dcterms:created>
  <dcterms:modified xsi:type="dcterms:W3CDTF">2023-02-03T06:46:04Z</dcterms:modified>
</cp:coreProperties>
</file>